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 showGuides="1">
      <p:cViewPr varScale="1">
        <p:scale>
          <a:sx n="111" d="100"/>
          <a:sy n="111" d="100"/>
        </p:scale>
        <p:origin x="456" y="102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1FF3967-1E7C-49AB-95C4-880F2AA9969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E07E4922-3056-4ECB-AA14-731C1659FE1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83527EC-262E-441F-8CD6-E4BB016544D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07B8F3-25D1-4666-BB0F-04B3952B6239}" type="datetimeFigureOut">
              <a:rPr lang="en-US" smtClean="0"/>
              <a:t>10/10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ACBA660-4960-489E-97EF-626B66012DE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08F5513-7C93-4BED-9C07-F581359C45B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D374B0-C9A8-46B4-A219-3B83D3A4B81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1726113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439D0EE-02F4-46CC-8A6D-8ABE77AFAAF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69729C8-3C9E-441A-B422-5AF5DABF5A5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3FEC395-A8F5-44A4-82EF-DB324F46FA4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07B8F3-25D1-4666-BB0F-04B3952B6239}" type="datetimeFigureOut">
              <a:rPr lang="en-US" smtClean="0"/>
              <a:t>10/10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E3094DC-A28C-4C5E-94AF-2C0DCA6E49B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9FDD4B1-841B-456E-9C1F-093E2C52F30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D374B0-C9A8-46B4-A219-3B83D3A4B81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8312172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597449E9-BD15-4728-BB39-817EDCB413B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D2C03F6-B969-46D8-B27D-086D5E0DDB2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64D09B7-F43F-46B1-B8FA-EF8B9E35DD1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07B8F3-25D1-4666-BB0F-04B3952B6239}" type="datetimeFigureOut">
              <a:rPr lang="en-US" smtClean="0"/>
              <a:t>10/10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37E6DCF-14F0-44BA-8CA6-0FE12BE9273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B6DE791-42AD-4762-AE78-10C816E8B7E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D374B0-C9A8-46B4-A219-3B83D3A4B81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0845466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C71EF62-3317-426F-94D1-7A92378CD41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B2DA447-A255-4150-BE75-9E191027F7B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44CEAA5-82AB-4996-B0C5-CE57FD8222B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07B8F3-25D1-4666-BB0F-04B3952B6239}" type="datetimeFigureOut">
              <a:rPr lang="en-US" smtClean="0"/>
              <a:t>10/10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92C007F-C244-4293-B980-3C464536DA3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860D999-3C78-4D76-9BBA-6AC60F48615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D374B0-C9A8-46B4-A219-3B83D3A4B81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067436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3A025B8-8D23-495F-8367-E291A1722D2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9EF1821-E166-4D23-A82F-1880D277F71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15B10C5-A81D-45C2-81F1-908C714FF1C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07B8F3-25D1-4666-BB0F-04B3952B6239}" type="datetimeFigureOut">
              <a:rPr lang="en-US" smtClean="0"/>
              <a:t>10/10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CAD76F9-A5FA-48BC-99FF-916B4619586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300746A-4E87-4B52-B6C0-F609A29F151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D374B0-C9A8-46B4-A219-3B83D3A4B81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3153271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1B8FFE0-FA04-45EE-9C43-BF742496968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D8C8F1D-54A6-48A0-ABED-4E0F1C92F1F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1938B06-9816-4262-862B-C85A5CE7436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EFCBDF6-87D1-4C24-913B-5CB1FDEA813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07B8F3-25D1-4666-BB0F-04B3952B6239}" type="datetimeFigureOut">
              <a:rPr lang="en-US" smtClean="0"/>
              <a:t>10/10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1530D06-1892-4ED5-81D0-AB815A0663F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DB967B8-EC15-4942-B6B5-14F4105DE65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D374B0-C9A8-46B4-A219-3B83D3A4B81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9219582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06C43C2-9D0D-4BCC-8963-FEB66D5C382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502506A-956D-4CF3-872F-BCFAD555E5A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92A1BDE-4DA5-41FE-B633-101CEBFC3F1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D796ACD1-9931-44EC-8AAD-C32B5A8E044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B4344DB1-AF6A-43CF-B843-577CDE3F7FC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7F5653D6-534E-4C6A-943C-4BBACE2B4B4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07B8F3-25D1-4666-BB0F-04B3952B6239}" type="datetimeFigureOut">
              <a:rPr lang="en-US" smtClean="0"/>
              <a:t>10/10/2023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3201BD69-BC0C-4647-967B-BFACB0B98FA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AA2595A6-7095-430A-B4FA-92FB709F7B0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D374B0-C9A8-46B4-A219-3B83D3A4B81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3904073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DC2A3D6-9139-4932-BA78-AB559B87769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A9BF7753-704F-4279-9EDE-A40F82C4DC3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07B8F3-25D1-4666-BB0F-04B3952B6239}" type="datetimeFigureOut">
              <a:rPr lang="en-US" smtClean="0"/>
              <a:t>10/10/2023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2AA6D7D1-0E5C-48C6-9F6A-2CE16A17758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18431B51-D2F8-4C49-BE64-540245EFA7D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D374B0-C9A8-46B4-A219-3B83D3A4B81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7576892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76501BA1-4D06-4550-B979-E2C831ED824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07B8F3-25D1-4666-BB0F-04B3952B6239}" type="datetimeFigureOut">
              <a:rPr lang="en-US" smtClean="0"/>
              <a:t>10/10/2023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2968689C-2F1D-4FDF-89AB-922BC4EEE93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93CDD9D4-D66A-4513-9A88-C8871F5A48F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D374B0-C9A8-46B4-A219-3B83D3A4B81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5673246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D652376-EC66-46AC-B1BD-7F7DA29F47A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A48178D-57EA-49AB-AFA9-B162702CE0D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5FBF0FE-54A2-439E-AD91-C2821BA4A53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CFC7E4D-45A2-4A0A-A3B6-2D55CB1F630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07B8F3-25D1-4666-BB0F-04B3952B6239}" type="datetimeFigureOut">
              <a:rPr lang="en-US" smtClean="0"/>
              <a:t>10/10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66AA849-CEC4-47C5-A570-DFE3291DF7E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CC6ACF2-236F-4166-9829-8328F3BC1F3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D374B0-C9A8-46B4-A219-3B83D3A4B81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7301907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87FA325-7F98-437A-A302-62DC83621D5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1C4642ED-8860-48B6-A339-19D40243EA0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A58BFE8-B6EA-4080-9303-A6B8B62AFDD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FF04F77-E4EF-457F-9050-F7237D49B9C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07B8F3-25D1-4666-BB0F-04B3952B6239}" type="datetimeFigureOut">
              <a:rPr lang="en-US" smtClean="0"/>
              <a:t>10/10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CCC4F85-1279-47D6-B224-C754936B3AF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BE77A7F-DE81-454D-BE96-ECA75E64346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D374B0-C9A8-46B4-A219-3B83D3A4B81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2897933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65C6BA49-13E5-41AB-A7E8-57D90C1B458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60E80EB-16EB-4179-917B-047D66F6021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5FC60E1-FD0D-4DF0-B673-A5CA7D810FF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C07B8F3-25D1-4666-BB0F-04B3952B6239}" type="datetimeFigureOut">
              <a:rPr lang="en-US" smtClean="0"/>
              <a:t>10/10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C5150C0-472D-4941-95F3-1156BD04B7F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4C5DC76-A412-406A-9659-F684CB2BCBE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D374B0-C9A8-46B4-A219-3B83D3A4B81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43817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E7FAE05E-69E5-4232-B66A-8A1A9A0CB625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-8132" b="-3962"/>
          <a:stretch/>
        </p:blipFill>
        <p:spPr>
          <a:xfrm>
            <a:off x="2405524" y="983412"/>
            <a:ext cx="7380952" cy="5796950"/>
          </a:xfrm>
          <a:prstGeom prst="rect">
            <a:avLst/>
          </a:prstGeom>
        </p:spPr>
      </p:pic>
      <p:sp>
        <p:nvSpPr>
          <p:cNvPr id="5" name="Rectangle 4">
            <a:extLst>
              <a:ext uri="{FF2B5EF4-FFF2-40B4-BE49-F238E27FC236}">
                <a16:creationId xmlns:a16="http://schemas.microsoft.com/office/drawing/2014/main" id="{156C3F50-F963-4E4E-9D7A-D39B2510BFE5}"/>
              </a:ext>
            </a:extLst>
          </p:cNvPr>
          <p:cNvSpPr/>
          <p:nvPr/>
        </p:nvSpPr>
        <p:spPr>
          <a:xfrm>
            <a:off x="3864634" y="2001327"/>
            <a:ext cx="2424023" cy="112143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AC1008E9-1FF9-4980-B25E-6F2E32558AD5}"/>
              </a:ext>
            </a:extLst>
          </p:cNvPr>
          <p:cNvSpPr txBox="1"/>
          <p:nvPr/>
        </p:nvSpPr>
        <p:spPr>
          <a:xfrm rot="18759723">
            <a:off x="4275447" y="1656921"/>
            <a:ext cx="64958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solidFill>
                  <a:srgbClr val="FF0000"/>
                </a:solidFill>
              </a:rPr>
              <a:t>14-121</a:t>
            </a:r>
            <a:endParaRPr lang="en-US" sz="1000" b="1" baseline="30000" dirty="0">
              <a:solidFill>
                <a:srgbClr val="FF0000"/>
              </a:solidFill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34D3CC5B-29FF-45E3-ABAA-651BE8C2C415}"/>
              </a:ext>
            </a:extLst>
          </p:cNvPr>
          <p:cNvSpPr txBox="1"/>
          <p:nvPr/>
        </p:nvSpPr>
        <p:spPr>
          <a:xfrm rot="18759723">
            <a:off x="3770994" y="1644006"/>
            <a:ext cx="68470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solidFill>
                  <a:srgbClr val="FF0000"/>
                </a:solidFill>
              </a:rPr>
              <a:t>14-066</a:t>
            </a:r>
            <a:endParaRPr lang="en-US" sz="1000" b="1" baseline="30000" dirty="0">
              <a:solidFill>
                <a:srgbClr val="FF0000"/>
              </a:solidFill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74077DC7-92BC-4CF8-8C93-CD4B57103F20}"/>
              </a:ext>
            </a:extLst>
          </p:cNvPr>
          <p:cNvSpPr txBox="1"/>
          <p:nvPr/>
        </p:nvSpPr>
        <p:spPr>
          <a:xfrm rot="18759723">
            <a:off x="6017100" y="1742350"/>
            <a:ext cx="42986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/>
              <a:t>PrP</a:t>
            </a:r>
            <a:r>
              <a:rPr lang="en-US" sz="1000" b="1" baseline="30000" dirty="0"/>
              <a:t>c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A4978B30-66F9-42C9-A4C1-99843B654AD2}"/>
              </a:ext>
            </a:extLst>
          </p:cNvPr>
          <p:cNvSpPr txBox="1"/>
          <p:nvPr/>
        </p:nvSpPr>
        <p:spPr>
          <a:xfrm rot="18759723">
            <a:off x="4468092" y="1658633"/>
            <a:ext cx="64515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solidFill>
                  <a:srgbClr val="FF0000"/>
                </a:solidFill>
              </a:rPr>
              <a:t>14-288</a:t>
            </a:r>
            <a:endParaRPr lang="en-US" sz="1000" b="1" baseline="30000" dirty="0">
              <a:solidFill>
                <a:srgbClr val="FF0000"/>
              </a:solidFill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CF03793A-5D42-4038-A455-5A7639A0918B}"/>
              </a:ext>
            </a:extLst>
          </p:cNvPr>
          <p:cNvSpPr txBox="1"/>
          <p:nvPr/>
        </p:nvSpPr>
        <p:spPr>
          <a:xfrm rot="18759723">
            <a:off x="4036021" y="1648047"/>
            <a:ext cx="67371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solidFill>
                  <a:srgbClr val="FF0000"/>
                </a:solidFill>
              </a:rPr>
              <a:t>14-101</a:t>
            </a:r>
            <a:endParaRPr lang="en-US" sz="1000" b="1" baseline="30000" dirty="0">
              <a:solidFill>
                <a:srgbClr val="FF0000"/>
              </a:solidFill>
            </a:endParaRP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D4CEEC51-1B70-42F1-8E9E-3F5E4D0AFAEE}"/>
              </a:ext>
            </a:extLst>
          </p:cNvPr>
          <p:cNvSpPr txBox="1"/>
          <p:nvPr/>
        </p:nvSpPr>
        <p:spPr>
          <a:xfrm rot="18759723">
            <a:off x="5187649" y="1688229"/>
            <a:ext cx="55743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/>
              <a:t>15-107</a:t>
            </a:r>
            <a:endParaRPr lang="en-US" sz="1000" b="1" baseline="30000" dirty="0"/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33F46B31-FA35-481F-AC77-031687502837}"/>
              </a:ext>
            </a:extLst>
          </p:cNvPr>
          <p:cNvSpPr txBox="1"/>
          <p:nvPr/>
        </p:nvSpPr>
        <p:spPr>
          <a:xfrm rot="18759723">
            <a:off x="4701271" y="1650999"/>
            <a:ext cx="66669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solidFill>
                  <a:srgbClr val="FF0000"/>
                </a:solidFill>
              </a:rPr>
              <a:t>14-290</a:t>
            </a:r>
            <a:endParaRPr lang="en-US" sz="1000" b="1" baseline="30000" dirty="0">
              <a:solidFill>
                <a:srgbClr val="FF0000"/>
              </a:solidFill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3B6056DE-9CFA-4BAB-B057-DA583351B88A}"/>
              </a:ext>
            </a:extLst>
          </p:cNvPr>
          <p:cNvSpPr txBox="1"/>
          <p:nvPr/>
        </p:nvSpPr>
        <p:spPr>
          <a:xfrm rot="18759723">
            <a:off x="5404707" y="1642629"/>
            <a:ext cx="68169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/>
              <a:t>15-108</a:t>
            </a:r>
            <a:endParaRPr lang="en-US" sz="1000" b="1" baseline="30000" dirty="0"/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2F0CFD43-ADCA-4C50-8D9F-7D48F229E954}"/>
              </a:ext>
            </a:extLst>
          </p:cNvPr>
          <p:cNvSpPr txBox="1"/>
          <p:nvPr/>
        </p:nvSpPr>
        <p:spPr>
          <a:xfrm rot="18759723">
            <a:off x="4933420" y="1631810"/>
            <a:ext cx="70086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solidFill>
                  <a:srgbClr val="FF0000"/>
                </a:solidFill>
              </a:rPr>
              <a:t>14-313</a:t>
            </a:r>
            <a:endParaRPr lang="en-US" sz="1000" b="1" baseline="30000" dirty="0">
              <a:solidFill>
                <a:srgbClr val="FF0000"/>
              </a:solidFill>
            </a:endParaRP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063F5309-E85E-4843-B7B9-D7ED92FC0965}"/>
              </a:ext>
            </a:extLst>
          </p:cNvPr>
          <p:cNvSpPr txBox="1"/>
          <p:nvPr/>
        </p:nvSpPr>
        <p:spPr>
          <a:xfrm rot="18759723">
            <a:off x="5608535" y="1605778"/>
            <a:ext cx="76051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/>
              <a:t>15-110</a:t>
            </a:r>
            <a:endParaRPr lang="en-US" sz="1000" b="1" baseline="30000" dirty="0"/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47D5639C-4953-4E49-B8FD-23DB71C30809}"/>
              </a:ext>
            </a:extLst>
          </p:cNvPr>
          <p:cNvSpPr txBox="1"/>
          <p:nvPr/>
        </p:nvSpPr>
        <p:spPr>
          <a:xfrm>
            <a:off x="183508" y="279443"/>
            <a:ext cx="860680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Figure 1.</a:t>
            </a:r>
            <a:r>
              <a:rPr lang="en-US" dirty="0"/>
              <a:t> Top panel (</a:t>
            </a:r>
            <a:r>
              <a:rPr lang="en-US" dirty="0" err="1"/>
              <a:t>NaPTA</a:t>
            </a:r>
            <a:r>
              <a:rPr lang="en-US" dirty="0"/>
              <a:t>) 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0188A54A-5721-4C52-9BD0-E36436BEC69E}"/>
              </a:ext>
            </a:extLst>
          </p:cNvPr>
          <p:cNvSpPr txBox="1"/>
          <p:nvPr/>
        </p:nvSpPr>
        <p:spPr>
          <a:xfrm>
            <a:off x="6395100" y="1968450"/>
            <a:ext cx="43759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/>
              <a:t>kDa</a:t>
            </a:r>
            <a:endParaRPr lang="en-US" sz="1000" b="1" baseline="30000" dirty="0"/>
          </a:p>
        </p:txBody>
      </p:sp>
      <p:cxnSp>
        <p:nvCxnSpPr>
          <p:cNvPr id="18" name="Straight Connector 17">
            <a:extLst>
              <a:ext uri="{FF2B5EF4-FFF2-40B4-BE49-F238E27FC236}">
                <a16:creationId xmlns:a16="http://schemas.microsoft.com/office/drawing/2014/main" id="{E3AFA17B-A939-4D44-A3B7-FD3CF8AB0F86}"/>
              </a:ext>
            </a:extLst>
          </p:cNvPr>
          <p:cNvCxnSpPr/>
          <p:nvPr/>
        </p:nvCxnSpPr>
        <p:spPr>
          <a:xfrm>
            <a:off x="6285274" y="2348149"/>
            <a:ext cx="173736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TextBox 18">
            <a:extLst>
              <a:ext uri="{FF2B5EF4-FFF2-40B4-BE49-F238E27FC236}">
                <a16:creationId xmlns:a16="http://schemas.microsoft.com/office/drawing/2014/main" id="{3EB6FF46-53AF-42C2-8ECE-E7F66F9C8ECF}"/>
              </a:ext>
            </a:extLst>
          </p:cNvPr>
          <p:cNvSpPr txBox="1"/>
          <p:nvPr/>
        </p:nvSpPr>
        <p:spPr>
          <a:xfrm>
            <a:off x="6407581" y="2218784"/>
            <a:ext cx="62179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34</a:t>
            </a:r>
          </a:p>
        </p:txBody>
      </p:sp>
      <p:cxnSp>
        <p:nvCxnSpPr>
          <p:cNvPr id="20" name="Straight Connector 19">
            <a:extLst>
              <a:ext uri="{FF2B5EF4-FFF2-40B4-BE49-F238E27FC236}">
                <a16:creationId xmlns:a16="http://schemas.microsoft.com/office/drawing/2014/main" id="{165D3290-494C-4523-A024-23580CD2C663}"/>
              </a:ext>
            </a:extLst>
          </p:cNvPr>
          <p:cNvCxnSpPr/>
          <p:nvPr/>
        </p:nvCxnSpPr>
        <p:spPr>
          <a:xfrm>
            <a:off x="6290415" y="2664448"/>
            <a:ext cx="173736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TextBox 20">
            <a:extLst>
              <a:ext uri="{FF2B5EF4-FFF2-40B4-BE49-F238E27FC236}">
                <a16:creationId xmlns:a16="http://schemas.microsoft.com/office/drawing/2014/main" id="{F687A93B-3334-43CF-B064-179F5E45D963}"/>
              </a:ext>
            </a:extLst>
          </p:cNvPr>
          <p:cNvSpPr txBox="1"/>
          <p:nvPr/>
        </p:nvSpPr>
        <p:spPr>
          <a:xfrm>
            <a:off x="6413332" y="2526456"/>
            <a:ext cx="62179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26</a:t>
            </a:r>
          </a:p>
        </p:txBody>
      </p:sp>
    </p:spTree>
    <p:extLst>
      <p:ext uri="{BB962C8B-B14F-4D97-AF65-F5344CB8AC3E}">
        <p14:creationId xmlns:p14="http://schemas.microsoft.com/office/powerpoint/2010/main" val="143970380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578AF2AC-B460-4D32-B946-C3089B5BCFD0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-5798" b="-6132"/>
          <a:stretch/>
        </p:blipFill>
        <p:spPr>
          <a:xfrm>
            <a:off x="2405524" y="543465"/>
            <a:ext cx="7380952" cy="5788324"/>
          </a:xfrm>
          <a:prstGeom prst="rect">
            <a:avLst/>
          </a:prstGeom>
        </p:spPr>
      </p:pic>
      <p:sp>
        <p:nvSpPr>
          <p:cNvPr id="3" name="Rectangle 2">
            <a:extLst>
              <a:ext uri="{FF2B5EF4-FFF2-40B4-BE49-F238E27FC236}">
                <a16:creationId xmlns:a16="http://schemas.microsoft.com/office/drawing/2014/main" id="{89C192AE-2B3B-4A9A-8732-21230602202D}"/>
              </a:ext>
            </a:extLst>
          </p:cNvPr>
          <p:cNvSpPr/>
          <p:nvPr/>
        </p:nvSpPr>
        <p:spPr>
          <a:xfrm>
            <a:off x="3295296" y="1250829"/>
            <a:ext cx="2424023" cy="112143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E7134E34-86D6-4EA3-AF43-2203E05D2CB8}"/>
              </a:ext>
            </a:extLst>
          </p:cNvPr>
          <p:cNvSpPr txBox="1"/>
          <p:nvPr/>
        </p:nvSpPr>
        <p:spPr>
          <a:xfrm rot="18759723">
            <a:off x="3680226" y="915048"/>
            <a:ext cx="64958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solidFill>
                  <a:srgbClr val="FF0000"/>
                </a:solidFill>
              </a:rPr>
              <a:t>14-121</a:t>
            </a:r>
            <a:endParaRPr lang="en-US" sz="1000" b="1" baseline="30000" dirty="0">
              <a:solidFill>
                <a:srgbClr val="FF0000"/>
              </a:solidFill>
            </a:endParaRP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06251DF1-56D7-45F6-985F-FFFBC8CAA80C}"/>
              </a:ext>
            </a:extLst>
          </p:cNvPr>
          <p:cNvSpPr txBox="1"/>
          <p:nvPr/>
        </p:nvSpPr>
        <p:spPr>
          <a:xfrm rot="18759723">
            <a:off x="3175773" y="902133"/>
            <a:ext cx="68470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solidFill>
                  <a:srgbClr val="FF0000"/>
                </a:solidFill>
              </a:rPr>
              <a:t>14-066</a:t>
            </a:r>
            <a:endParaRPr lang="en-US" sz="1000" b="1" baseline="30000" dirty="0">
              <a:solidFill>
                <a:srgbClr val="FF0000"/>
              </a:solidFill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EDDCE4A7-3F26-4C97-9445-3BA615D31F0E}"/>
              </a:ext>
            </a:extLst>
          </p:cNvPr>
          <p:cNvSpPr txBox="1"/>
          <p:nvPr/>
        </p:nvSpPr>
        <p:spPr>
          <a:xfrm rot="18759723">
            <a:off x="5421879" y="1000477"/>
            <a:ext cx="42986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/>
              <a:t>PrP</a:t>
            </a:r>
            <a:r>
              <a:rPr lang="en-US" sz="1000" b="1" baseline="30000" dirty="0"/>
              <a:t>c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83BD73E6-0011-4D73-AC3B-D242295A8D45}"/>
              </a:ext>
            </a:extLst>
          </p:cNvPr>
          <p:cNvSpPr txBox="1"/>
          <p:nvPr/>
        </p:nvSpPr>
        <p:spPr>
          <a:xfrm rot="18759723">
            <a:off x="3872871" y="916760"/>
            <a:ext cx="64515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solidFill>
                  <a:srgbClr val="FF0000"/>
                </a:solidFill>
              </a:rPr>
              <a:t>14-288</a:t>
            </a:r>
            <a:endParaRPr lang="en-US" sz="1000" b="1" baseline="30000" dirty="0">
              <a:solidFill>
                <a:srgbClr val="FF0000"/>
              </a:solidFill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4E74A260-CEF6-44D6-8A29-437E52DFB17C}"/>
              </a:ext>
            </a:extLst>
          </p:cNvPr>
          <p:cNvSpPr txBox="1"/>
          <p:nvPr/>
        </p:nvSpPr>
        <p:spPr>
          <a:xfrm rot="18759723">
            <a:off x="3440800" y="906174"/>
            <a:ext cx="67371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solidFill>
                  <a:srgbClr val="FF0000"/>
                </a:solidFill>
              </a:rPr>
              <a:t>14-101</a:t>
            </a:r>
            <a:endParaRPr lang="en-US" sz="1000" b="1" baseline="30000" dirty="0">
              <a:solidFill>
                <a:srgbClr val="FF0000"/>
              </a:solidFill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FE3396D7-885F-4A7B-AE94-139DE2ACBAC9}"/>
              </a:ext>
            </a:extLst>
          </p:cNvPr>
          <p:cNvSpPr txBox="1"/>
          <p:nvPr/>
        </p:nvSpPr>
        <p:spPr>
          <a:xfrm rot="18759723">
            <a:off x="4592428" y="946356"/>
            <a:ext cx="55743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/>
              <a:t>15-107</a:t>
            </a:r>
            <a:endParaRPr lang="en-US" sz="1000" b="1" baseline="30000" dirty="0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F9458251-998C-4E89-8B69-8501EA7BF124}"/>
              </a:ext>
            </a:extLst>
          </p:cNvPr>
          <p:cNvSpPr txBox="1"/>
          <p:nvPr/>
        </p:nvSpPr>
        <p:spPr>
          <a:xfrm rot="18759723">
            <a:off x="4106050" y="909126"/>
            <a:ext cx="66669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solidFill>
                  <a:srgbClr val="FF0000"/>
                </a:solidFill>
              </a:rPr>
              <a:t>14-290</a:t>
            </a:r>
            <a:endParaRPr lang="en-US" sz="1000" b="1" baseline="30000" dirty="0">
              <a:solidFill>
                <a:srgbClr val="FF0000"/>
              </a:solidFill>
            </a:endParaRP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DC2F0BF6-EBB1-45B0-997D-34DA7CAAE37B}"/>
              </a:ext>
            </a:extLst>
          </p:cNvPr>
          <p:cNvSpPr txBox="1"/>
          <p:nvPr/>
        </p:nvSpPr>
        <p:spPr>
          <a:xfrm rot="18759723">
            <a:off x="4809486" y="900756"/>
            <a:ext cx="68169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/>
              <a:t>15-108</a:t>
            </a:r>
            <a:endParaRPr lang="en-US" sz="1000" b="1" baseline="30000" dirty="0"/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F61931FC-69A1-4628-B145-F3D56D3E1256}"/>
              </a:ext>
            </a:extLst>
          </p:cNvPr>
          <p:cNvSpPr txBox="1"/>
          <p:nvPr/>
        </p:nvSpPr>
        <p:spPr>
          <a:xfrm rot="18759723">
            <a:off x="4338199" y="889937"/>
            <a:ext cx="70086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solidFill>
                  <a:srgbClr val="FF0000"/>
                </a:solidFill>
              </a:rPr>
              <a:t>14-313</a:t>
            </a:r>
            <a:endParaRPr lang="en-US" sz="1000" b="1" baseline="30000" dirty="0">
              <a:solidFill>
                <a:srgbClr val="FF0000"/>
              </a:solidFill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9797DC85-C366-4DDB-865D-564370F5B61A}"/>
              </a:ext>
            </a:extLst>
          </p:cNvPr>
          <p:cNvSpPr txBox="1"/>
          <p:nvPr/>
        </p:nvSpPr>
        <p:spPr>
          <a:xfrm rot="18759723">
            <a:off x="5013314" y="863905"/>
            <a:ext cx="76051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/>
              <a:t>15-110</a:t>
            </a:r>
            <a:endParaRPr lang="en-US" sz="1000" b="1" baseline="30000" dirty="0"/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DCBF1162-750E-4A35-9F45-36A554E63952}"/>
              </a:ext>
            </a:extLst>
          </p:cNvPr>
          <p:cNvSpPr txBox="1"/>
          <p:nvPr/>
        </p:nvSpPr>
        <p:spPr>
          <a:xfrm>
            <a:off x="209387" y="219058"/>
            <a:ext cx="988351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Figure 1.</a:t>
            </a:r>
            <a:r>
              <a:rPr lang="en-US" dirty="0"/>
              <a:t> Middle panel (ultracentrifugation) </a:t>
            </a:r>
          </a:p>
        </p:txBody>
      </p:sp>
      <p:cxnSp>
        <p:nvCxnSpPr>
          <p:cNvPr id="15" name="Straight Connector 14">
            <a:extLst>
              <a:ext uri="{FF2B5EF4-FFF2-40B4-BE49-F238E27FC236}">
                <a16:creationId xmlns:a16="http://schemas.microsoft.com/office/drawing/2014/main" id="{AF0A1161-F2EF-43BE-AE8A-00E267D92550}"/>
              </a:ext>
            </a:extLst>
          </p:cNvPr>
          <p:cNvCxnSpPr/>
          <p:nvPr/>
        </p:nvCxnSpPr>
        <p:spPr>
          <a:xfrm>
            <a:off x="5724557" y="1683915"/>
            <a:ext cx="173736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TextBox 15">
            <a:extLst>
              <a:ext uri="{FF2B5EF4-FFF2-40B4-BE49-F238E27FC236}">
                <a16:creationId xmlns:a16="http://schemas.microsoft.com/office/drawing/2014/main" id="{A21CC9A0-8F79-4E02-BAAA-58E504D910D5}"/>
              </a:ext>
            </a:extLst>
          </p:cNvPr>
          <p:cNvSpPr txBox="1"/>
          <p:nvPr/>
        </p:nvSpPr>
        <p:spPr>
          <a:xfrm>
            <a:off x="5846864" y="1554550"/>
            <a:ext cx="62179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34</a:t>
            </a:r>
          </a:p>
        </p:txBody>
      </p:sp>
      <p:cxnSp>
        <p:nvCxnSpPr>
          <p:cNvPr id="17" name="Straight Connector 16">
            <a:extLst>
              <a:ext uri="{FF2B5EF4-FFF2-40B4-BE49-F238E27FC236}">
                <a16:creationId xmlns:a16="http://schemas.microsoft.com/office/drawing/2014/main" id="{6E2428F5-97E1-48D4-9CA4-0C37A00DFAF9}"/>
              </a:ext>
            </a:extLst>
          </p:cNvPr>
          <p:cNvCxnSpPr/>
          <p:nvPr/>
        </p:nvCxnSpPr>
        <p:spPr>
          <a:xfrm>
            <a:off x="5729698" y="2000214"/>
            <a:ext cx="173736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TextBox 17">
            <a:extLst>
              <a:ext uri="{FF2B5EF4-FFF2-40B4-BE49-F238E27FC236}">
                <a16:creationId xmlns:a16="http://schemas.microsoft.com/office/drawing/2014/main" id="{45DF6146-50A4-44C9-9C7A-D4D8D7C811C8}"/>
              </a:ext>
            </a:extLst>
          </p:cNvPr>
          <p:cNvSpPr txBox="1"/>
          <p:nvPr/>
        </p:nvSpPr>
        <p:spPr>
          <a:xfrm>
            <a:off x="5852615" y="1862222"/>
            <a:ext cx="62179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26</a:t>
            </a:r>
          </a:p>
        </p:txBody>
      </p:sp>
    </p:spTree>
    <p:extLst>
      <p:ext uri="{BB962C8B-B14F-4D97-AF65-F5344CB8AC3E}">
        <p14:creationId xmlns:p14="http://schemas.microsoft.com/office/powerpoint/2010/main" val="427367815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306A41F7-7134-484A-BF73-279052AECBF3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-10301" b="-12637"/>
          <a:stretch/>
        </p:blipFill>
        <p:spPr>
          <a:xfrm>
            <a:off x="2405524" y="310551"/>
            <a:ext cx="7380952" cy="6357668"/>
          </a:xfrm>
          <a:prstGeom prst="rect">
            <a:avLst/>
          </a:prstGeom>
        </p:spPr>
      </p:pic>
      <p:sp>
        <p:nvSpPr>
          <p:cNvPr id="3" name="Rectangle 2">
            <a:extLst>
              <a:ext uri="{FF2B5EF4-FFF2-40B4-BE49-F238E27FC236}">
                <a16:creationId xmlns:a16="http://schemas.microsoft.com/office/drawing/2014/main" id="{D854B0DE-E3FC-4E70-A2EC-842CB3F0E3B4}"/>
              </a:ext>
            </a:extLst>
          </p:cNvPr>
          <p:cNvSpPr/>
          <p:nvPr/>
        </p:nvSpPr>
        <p:spPr>
          <a:xfrm>
            <a:off x="3226288" y="2786319"/>
            <a:ext cx="2424023" cy="112143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3615895A-ED01-47CE-AAE3-DE2D4F4FA242}"/>
              </a:ext>
            </a:extLst>
          </p:cNvPr>
          <p:cNvSpPr txBox="1"/>
          <p:nvPr/>
        </p:nvSpPr>
        <p:spPr>
          <a:xfrm rot="18759723">
            <a:off x="3662973" y="2441924"/>
            <a:ext cx="64958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solidFill>
                  <a:srgbClr val="FF0000"/>
                </a:solidFill>
              </a:rPr>
              <a:t>14-121</a:t>
            </a:r>
            <a:endParaRPr lang="en-US" sz="1000" b="1" baseline="30000" dirty="0">
              <a:solidFill>
                <a:srgbClr val="FF0000"/>
              </a:solidFill>
            </a:endParaRP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3E6C05D7-F5C5-4F21-BC1E-7A5F0CCE5411}"/>
              </a:ext>
            </a:extLst>
          </p:cNvPr>
          <p:cNvSpPr txBox="1"/>
          <p:nvPr/>
        </p:nvSpPr>
        <p:spPr>
          <a:xfrm rot="18759723">
            <a:off x="3158520" y="2429009"/>
            <a:ext cx="68470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solidFill>
                  <a:srgbClr val="FF0000"/>
                </a:solidFill>
              </a:rPr>
              <a:t>14-066</a:t>
            </a:r>
            <a:endParaRPr lang="en-US" sz="1000" b="1" baseline="30000" dirty="0">
              <a:solidFill>
                <a:srgbClr val="FF0000"/>
              </a:solidFill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A97F7D8D-EA6A-4C78-BA90-827917295963}"/>
              </a:ext>
            </a:extLst>
          </p:cNvPr>
          <p:cNvSpPr txBox="1"/>
          <p:nvPr/>
        </p:nvSpPr>
        <p:spPr>
          <a:xfrm rot="18759723">
            <a:off x="5404626" y="2527353"/>
            <a:ext cx="42986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/>
              <a:t>PrP</a:t>
            </a:r>
            <a:r>
              <a:rPr lang="en-US" sz="1000" b="1" baseline="30000" dirty="0"/>
              <a:t>c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D10D0E3A-7C7B-4E6C-BD30-89DB82FCCC14}"/>
              </a:ext>
            </a:extLst>
          </p:cNvPr>
          <p:cNvSpPr txBox="1"/>
          <p:nvPr/>
        </p:nvSpPr>
        <p:spPr>
          <a:xfrm rot="18759723">
            <a:off x="3855618" y="2443636"/>
            <a:ext cx="64515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solidFill>
                  <a:srgbClr val="FF0000"/>
                </a:solidFill>
              </a:rPr>
              <a:t>14-288</a:t>
            </a:r>
            <a:endParaRPr lang="en-US" sz="1000" b="1" baseline="30000" dirty="0">
              <a:solidFill>
                <a:srgbClr val="FF0000"/>
              </a:solidFill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484A43F6-BB6D-4A6B-A987-36B3EA88A7CB}"/>
              </a:ext>
            </a:extLst>
          </p:cNvPr>
          <p:cNvSpPr txBox="1"/>
          <p:nvPr/>
        </p:nvSpPr>
        <p:spPr>
          <a:xfrm rot="18759723">
            <a:off x="3423547" y="2433050"/>
            <a:ext cx="67371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solidFill>
                  <a:srgbClr val="FF0000"/>
                </a:solidFill>
              </a:rPr>
              <a:t>14-101</a:t>
            </a:r>
            <a:endParaRPr lang="en-US" sz="1000" b="1" baseline="30000" dirty="0">
              <a:solidFill>
                <a:srgbClr val="FF0000"/>
              </a:solidFill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E494D9C1-5B34-4690-AD16-DB72A7CE14CB}"/>
              </a:ext>
            </a:extLst>
          </p:cNvPr>
          <p:cNvSpPr txBox="1"/>
          <p:nvPr/>
        </p:nvSpPr>
        <p:spPr>
          <a:xfrm rot="18759723">
            <a:off x="4575175" y="2473232"/>
            <a:ext cx="55743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/>
              <a:t>15-107</a:t>
            </a:r>
            <a:endParaRPr lang="en-US" sz="1000" b="1" baseline="30000" dirty="0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3B9D0B0B-9E9E-4ECE-8891-9F5628EB464C}"/>
              </a:ext>
            </a:extLst>
          </p:cNvPr>
          <p:cNvSpPr txBox="1"/>
          <p:nvPr/>
        </p:nvSpPr>
        <p:spPr>
          <a:xfrm rot="18759723">
            <a:off x="4088797" y="2436002"/>
            <a:ext cx="66669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solidFill>
                  <a:srgbClr val="FF0000"/>
                </a:solidFill>
              </a:rPr>
              <a:t>14-290</a:t>
            </a:r>
            <a:endParaRPr lang="en-US" sz="1000" b="1" baseline="30000" dirty="0">
              <a:solidFill>
                <a:srgbClr val="FF0000"/>
              </a:solidFill>
            </a:endParaRP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7F3CAAF9-3253-41B8-A262-2F4C2DD3575C}"/>
              </a:ext>
            </a:extLst>
          </p:cNvPr>
          <p:cNvSpPr txBox="1"/>
          <p:nvPr/>
        </p:nvSpPr>
        <p:spPr>
          <a:xfrm rot="18759723">
            <a:off x="4792233" y="2427632"/>
            <a:ext cx="68169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/>
              <a:t>15-108</a:t>
            </a:r>
            <a:endParaRPr lang="en-US" sz="1000" b="1" baseline="30000" dirty="0"/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50FB7072-8DA2-4CB2-842B-96342B3F58F1}"/>
              </a:ext>
            </a:extLst>
          </p:cNvPr>
          <p:cNvSpPr txBox="1"/>
          <p:nvPr/>
        </p:nvSpPr>
        <p:spPr>
          <a:xfrm rot="18759723">
            <a:off x="4320946" y="2416813"/>
            <a:ext cx="70086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solidFill>
                  <a:srgbClr val="FF0000"/>
                </a:solidFill>
              </a:rPr>
              <a:t>14-313</a:t>
            </a:r>
            <a:endParaRPr lang="en-US" sz="1000" b="1" baseline="30000" dirty="0">
              <a:solidFill>
                <a:srgbClr val="FF0000"/>
              </a:solidFill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4C4C43BB-ABBB-4270-86D3-ECE30FB22777}"/>
              </a:ext>
            </a:extLst>
          </p:cNvPr>
          <p:cNvSpPr txBox="1"/>
          <p:nvPr/>
        </p:nvSpPr>
        <p:spPr>
          <a:xfrm rot="18759723">
            <a:off x="4996061" y="2390781"/>
            <a:ext cx="76051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/>
              <a:t>15-110</a:t>
            </a:r>
            <a:endParaRPr lang="en-US" sz="1000" b="1" baseline="30000" dirty="0"/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F533DEA1-1291-4E71-8E62-983F47984A5B}"/>
              </a:ext>
            </a:extLst>
          </p:cNvPr>
          <p:cNvSpPr txBox="1"/>
          <p:nvPr/>
        </p:nvSpPr>
        <p:spPr>
          <a:xfrm>
            <a:off x="183508" y="279443"/>
            <a:ext cx="860680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Figure 1.</a:t>
            </a:r>
            <a:r>
              <a:rPr lang="en-US" dirty="0"/>
              <a:t> Bottom panel (Direct) </a:t>
            </a:r>
          </a:p>
        </p:txBody>
      </p:sp>
      <p:cxnSp>
        <p:nvCxnSpPr>
          <p:cNvPr id="15" name="Straight Connector 14">
            <a:extLst>
              <a:ext uri="{FF2B5EF4-FFF2-40B4-BE49-F238E27FC236}">
                <a16:creationId xmlns:a16="http://schemas.microsoft.com/office/drawing/2014/main" id="{FAD9FEBD-9BE6-4E70-9D00-4082AFD855B2}"/>
              </a:ext>
            </a:extLst>
          </p:cNvPr>
          <p:cNvCxnSpPr/>
          <p:nvPr/>
        </p:nvCxnSpPr>
        <p:spPr>
          <a:xfrm>
            <a:off x="5655549" y="3184909"/>
            <a:ext cx="173736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TextBox 15">
            <a:extLst>
              <a:ext uri="{FF2B5EF4-FFF2-40B4-BE49-F238E27FC236}">
                <a16:creationId xmlns:a16="http://schemas.microsoft.com/office/drawing/2014/main" id="{1D8A7EF1-9FAA-4A30-B6D7-767511027CD7}"/>
              </a:ext>
            </a:extLst>
          </p:cNvPr>
          <p:cNvSpPr txBox="1"/>
          <p:nvPr/>
        </p:nvSpPr>
        <p:spPr>
          <a:xfrm>
            <a:off x="5777856" y="3055544"/>
            <a:ext cx="62179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34</a:t>
            </a:r>
          </a:p>
        </p:txBody>
      </p:sp>
      <p:cxnSp>
        <p:nvCxnSpPr>
          <p:cNvPr id="17" name="Straight Connector 16">
            <a:extLst>
              <a:ext uri="{FF2B5EF4-FFF2-40B4-BE49-F238E27FC236}">
                <a16:creationId xmlns:a16="http://schemas.microsoft.com/office/drawing/2014/main" id="{DA32F484-6582-41F0-AD31-EC7700EBAA20}"/>
              </a:ext>
            </a:extLst>
          </p:cNvPr>
          <p:cNvCxnSpPr/>
          <p:nvPr/>
        </p:nvCxnSpPr>
        <p:spPr>
          <a:xfrm>
            <a:off x="5660690" y="3501208"/>
            <a:ext cx="173736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TextBox 17">
            <a:extLst>
              <a:ext uri="{FF2B5EF4-FFF2-40B4-BE49-F238E27FC236}">
                <a16:creationId xmlns:a16="http://schemas.microsoft.com/office/drawing/2014/main" id="{DBFE83DF-9F38-4E56-AA61-EA2737430A15}"/>
              </a:ext>
            </a:extLst>
          </p:cNvPr>
          <p:cNvSpPr txBox="1"/>
          <p:nvPr/>
        </p:nvSpPr>
        <p:spPr>
          <a:xfrm>
            <a:off x="5783607" y="3363216"/>
            <a:ext cx="62179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26</a:t>
            </a:r>
          </a:p>
        </p:txBody>
      </p:sp>
    </p:spTree>
    <p:extLst>
      <p:ext uri="{BB962C8B-B14F-4D97-AF65-F5344CB8AC3E}">
        <p14:creationId xmlns:p14="http://schemas.microsoft.com/office/powerpoint/2010/main" val="279279169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4</TotalTime>
  <Words>61</Words>
  <Application>Microsoft Office PowerPoint</Application>
  <PresentationFormat>Widescreen</PresentationFormat>
  <Paragraphs>40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7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ravo Risi, Francisca C</dc:creator>
  <cp:lastModifiedBy>Bravo Risi, Francisca C</cp:lastModifiedBy>
  <cp:revision>2</cp:revision>
  <dcterms:created xsi:type="dcterms:W3CDTF">2023-10-10T22:00:17Z</dcterms:created>
  <dcterms:modified xsi:type="dcterms:W3CDTF">2023-10-10T22:45:34Z</dcterms:modified>
</cp:coreProperties>
</file>